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526" r:id="rId2"/>
    <p:sldId id="528" r:id="rId3"/>
    <p:sldId id="529" r:id="rId4"/>
    <p:sldId id="530" r:id="rId5"/>
    <p:sldId id="605" r:id="rId6"/>
    <p:sldId id="635" r:id="rId7"/>
    <p:sldId id="636" r:id="rId8"/>
    <p:sldId id="639" r:id="rId9"/>
    <p:sldId id="640" r:id="rId10"/>
    <p:sldId id="641" r:id="rId11"/>
    <p:sldId id="603" r:id="rId1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129" autoAdjust="0"/>
    <p:restoredTop sz="89091" autoAdjust="0"/>
  </p:normalViewPr>
  <p:slideViewPr>
    <p:cSldViewPr snapToGrid="0">
      <p:cViewPr varScale="1">
        <p:scale>
          <a:sx n="78" d="100"/>
          <a:sy n="78" d="100"/>
        </p:scale>
        <p:origin x="1056" y="43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57B5D0-1633-438C-A879-62D61006E537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D2BE6E-3A3D-4B7C-AF7F-2D0430DF40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9839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1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13602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10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10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34166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11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1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69446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2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65636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3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03164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4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61834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5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64172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6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38750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7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139029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8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286905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9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2BE6E-3A3D-4B7C-AF7F-2D0430DF40EB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7256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BF7E7A-DAB8-49D2-8981-C945CE9EEE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687B03-96AD-4A29-91E3-5A7626A6B8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6F7E800-2045-43E9-BB4B-A88614276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B9C90D-FFFB-4388-BC8E-BF3F176C1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CDB882C-03A4-49E7-9F2A-5BB07E524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561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ED1E03-0136-4C7A-8018-1FF786EEB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4E724E7-776D-404F-8D94-5303060FD8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44C98C9-08B8-4816-9900-4D5179AAC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100044-4156-4FEB-9F81-D46CBE846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1F13CD4-74A3-44D4-941F-627945592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6019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EEDD697-2598-4364-AF00-C8AC35C5E8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B25A3F6-46FC-4524-B92A-690F34C4BA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5DB3F99-A720-4E15-841E-D1C97E1A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55827B9-D528-4768-B663-12C0B331A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59E2F9C-E5DE-49D9-B096-EA3EFFF9E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6725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A0560E1-7BBF-4F3B-B104-286F400DEA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61BD225-C0F4-4B96-8CC9-2B7B38726B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FAE1B13-D39F-4607-88FF-761CBC250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4BDEEB-F55A-4281-A249-ECD14D7AA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B77DD8-ECA5-40B5-8161-B258D5D55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194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C56184-0D5F-4E67-9708-8F6DC7E8E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3557515-EAC1-4F14-AB69-7F4EBC32B8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0765E6A-CF86-45AC-907D-AF634157C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89A550-B7A4-4774-8780-15FC9F3E1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9FB3DBA-DA32-45D5-87EA-5D77E8F49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0162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226DF32-3A8E-4C20-93CB-1C18E49960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A6CBD6E-EC76-4B2B-AEB9-33D4D42F0B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6CBC1D2-7B7F-4CAE-97DA-A6630C0B0E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582AFA9-1D81-4A7A-B379-0F338F43B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8390032-0A99-43A7-97F0-66D74C156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CF1E5B4-B909-4EE8-A421-D786B499C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9768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C5FB7A8-7827-4026-B24D-825A5D5C8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0DF54B6-124C-44E2-B661-E09F8E370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A0B1EA4-19D2-4FFC-A34C-433042FDF3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8F2DA506-EA43-4536-8F16-70CB563E2F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525F2ED-DDAC-4DFB-A1A3-34A6CE63D4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7B26B42-229F-4035-B631-F55E976DA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4663391-594F-4E96-A6C0-3FC3A75ED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727BB2F-25A1-4274-B8E6-E71A27CF5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1968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FD7F2C-0CD2-486E-BEB0-3023C7161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56051E9-CAA4-4B98-997F-72A54C80E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285AD01-4ED9-483A-AF80-B80F42893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C6C031E-B3A1-4D62-ABCE-A4C23E98B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8923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125ACD-5526-417B-8D78-B99BAED5A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FA0B9E8-DB23-407F-8D53-EC12DD2E5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CDE714B-CF2A-40F0-8DE9-F799F98B0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3252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C8DF229-683E-4E6B-AA09-E54EF7E40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4021A64-FCEB-47FB-BF43-C55E3E13BB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5A5F2E4-C146-41E5-B055-E4163CE2F1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FCF505B-1D0A-4AB3-A5FD-85E0F6C82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6DE91B4-350E-483D-836A-0993B928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A16EF28-AEB7-4CC7-B548-BECE61B7D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8117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BECC58-A5B9-40F4-9428-B2DEA79697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3919D2E-EFBD-455A-A747-0B59752B2E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357D744-B8E0-4772-9A94-FBB4B3BA5F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3FDCDC3-2D1F-4446-AA3B-27D46E130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5D5B950-5481-4C7C-9D82-18BA29070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ACE27C6-4023-4C74-B392-2E1BC0AA0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2985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A00FD97-0DC3-4C01-B44A-D74CB0DF50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22E7767-C609-4E40-8C38-0AD9933B8C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9AFCAE-D43E-431D-8C6E-B2CBA897AD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5CDA0-53D6-4AED-B726-D714E1315938}" type="datetimeFigureOut">
              <a:rPr lang="ko-KR" altLang="en-US" smtClean="0"/>
              <a:t>2024-03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DB44A28-5D3D-4D87-B2EF-9A92A67374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7E3ECB4-6E0A-40EF-8281-6259CB04C0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66356-32CB-4E4A-8349-243B690F23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5219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>
            <a:extLst>
              <a:ext uri="{FF2B5EF4-FFF2-40B4-BE49-F238E27FC236}">
                <a16:creationId xmlns:a16="http://schemas.microsoft.com/office/drawing/2014/main" id="{90D9211F-548B-BBF0-82C8-89DA75F7495B}"/>
              </a:ext>
            </a:extLst>
          </p:cNvPr>
          <p:cNvGrpSpPr/>
          <p:nvPr/>
        </p:nvGrpSpPr>
        <p:grpSpPr>
          <a:xfrm>
            <a:off x="-332879" y="-1"/>
            <a:ext cx="14415112" cy="11490251"/>
            <a:chOff x="-332879" y="-1"/>
            <a:chExt cx="14415112" cy="11490251"/>
          </a:xfrm>
        </p:grpSpPr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F74A0713-0DB3-9480-4451-3D2E78623E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7673443"/>
              <a:ext cx="7041116" cy="3795397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6F470CEC-A268-662F-61DF-2C04889F028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41116" y="7671518"/>
              <a:ext cx="7041117" cy="3795398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D77DC001-5B52-FD60-E05F-238A7167E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11008" y="3752178"/>
              <a:ext cx="7041117" cy="3795398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8FCFCBC2-D9B2-2287-F00E-FD6BB81A35A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3882328"/>
              <a:ext cx="7041116" cy="3795397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01864714-BF7A-A232-BE96-CF9E7C204DB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011008" y="-1"/>
              <a:ext cx="7041116" cy="3795397"/>
            </a:xfrm>
            <a:prstGeom prst="rect">
              <a:avLst/>
            </a:prstGeom>
          </p:spPr>
        </p:pic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AC38757B-C1E4-B941-74A5-2E11C4DC879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0" y="0"/>
              <a:ext cx="7011008" cy="377916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318810" y="40156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678129" y="3878479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719210" y="13276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332879" y="396358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75714" y="776065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790638" y="7756881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AD05375-E761-E94E-22F2-43F220BDD312}"/>
                </a:ext>
              </a:extLst>
            </p:cNvPr>
            <p:cNvSpPr txBox="1"/>
            <p:nvPr/>
          </p:nvSpPr>
          <p:spPr>
            <a:xfrm>
              <a:off x="-332878" y="47490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D38CFC1-10E6-E21A-E025-41F27286AF0B}"/>
                </a:ext>
              </a:extLst>
            </p:cNvPr>
            <p:cNvSpPr txBox="1"/>
            <p:nvPr/>
          </p:nvSpPr>
          <p:spPr>
            <a:xfrm>
              <a:off x="2753605" y="3512308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A02F15B-09BD-5A4E-CDC8-238BCC5E8758}"/>
                </a:ext>
              </a:extLst>
            </p:cNvPr>
            <p:cNvSpPr txBox="1"/>
            <p:nvPr/>
          </p:nvSpPr>
          <p:spPr>
            <a:xfrm>
              <a:off x="6685723" y="473242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4BF5444-7411-A342-436B-946960C68386}"/>
                </a:ext>
              </a:extLst>
            </p:cNvPr>
            <p:cNvSpPr txBox="1"/>
            <p:nvPr/>
          </p:nvSpPr>
          <p:spPr>
            <a:xfrm>
              <a:off x="9759966" y="3510044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9DFD8AE-46DA-6FF1-1E21-2C4260936EA9}"/>
                </a:ext>
              </a:extLst>
            </p:cNvPr>
            <p:cNvSpPr txBox="1"/>
            <p:nvPr/>
          </p:nvSpPr>
          <p:spPr>
            <a:xfrm>
              <a:off x="-332879" y="4345604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E7611FF-4368-BFDD-A3EF-6C2C4DB65198}"/>
                </a:ext>
              </a:extLst>
            </p:cNvPr>
            <p:cNvSpPr txBox="1"/>
            <p:nvPr/>
          </p:nvSpPr>
          <p:spPr>
            <a:xfrm>
              <a:off x="2240298" y="7331040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CBF5A88-6823-2CB2-BF8A-26C4A22F87CA}"/>
                </a:ext>
              </a:extLst>
            </p:cNvPr>
            <p:cNvSpPr txBox="1"/>
            <p:nvPr/>
          </p:nvSpPr>
          <p:spPr>
            <a:xfrm>
              <a:off x="6685723" y="4225421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E9428FA-9DB7-94E3-3599-9F267179483F}"/>
                </a:ext>
              </a:extLst>
            </p:cNvPr>
            <p:cNvSpPr txBox="1"/>
            <p:nvPr/>
          </p:nvSpPr>
          <p:spPr>
            <a:xfrm>
              <a:off x="9647273" y="7331040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87C5204-100D-A805-B34D-22F9E388FDA0}"/>
                </a:ext>
              </a:extLst>
            </p:cNvPr>
            <p:cNvSpPr txBox="1"/>
            <p:nvPr/>
          </p:nvSpPr>
          <p:spPr>
            <a:xfrm>
              <a:off x="-318810" y="8093253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9F6C07D-9987-8FBE-43F8-8547799F562B}"/>
                </a:ext>
              </a:extLst>
            </p:cNvPr>
            <p:cNvSpPr txBox="1"/>
            <p:nvPr/>
          </p:nvSpPr>
          <p:spPr>
            <a:xfrm>
              <a:off x="6722306" y="8101543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E45D209-7770-9383-AA43-2C9384EA0794}"/>
                </a:ext>
              </a:extLst>
            </p:cNvPr>
            <p:cNvSpPr txBox="1"/>
            <p:nvPr/>
          </p:nvSpPr>
          <p:spPr>
            <a:xfrm>
              <a:off x="9853870" y="11151696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28E0D1E-949A-93A5-1408-3828B628C3AE}"/>
                </a:ext>
              </a:extLst>
            </p:cNvPr>
            <p:cNvSpPr txBox="1"/>
            <p:nvPr/>
          </p:nvSpPr>
          <p:spPr>
            <a:xfrm>
              <a:off x="2624943" y="11147698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014250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ABBF15D5-27A6-D02C-3868-0CFF2618A9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035747"/>
            <a:ext cx="7779462" cy="4222718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A6DCCB3E-72D7-195A-0C55-FF633BCE93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04758" y="8088592"/>
            <a:ext cx="7682106" cy="4169873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2A100A8D-0962-810D-ABAB-06A68E9BE2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17405" y="3989170"/>
            <a:ext cx="7779461" cy="4222718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98D2E308-6183-5371-EBFF-416C80EF78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059622"/>
            <a:ext cx="7519877" cy="4081815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4CA1E25F-9FDD-9B4C-D75B-14C90E583D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04758" y="11315"/>
            <a:ext cx="7604757" cy="4127888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1077D9A4-715B-4051-8353-35FDB73CE4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65" y="13045"/>
            <a:ext cx="7604758" cy="41278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219284" y="280019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a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327764" y="4366762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d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364904" y="328779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b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360019" y="4368886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c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303120" y="8345421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e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21695" y="8341660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f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5803D25-0048-1921-0CD3-5F496BC88268}"/>
              </a:ext>
            </a:extLst>
          </p:cNvPr>
          <p:cNvSpPr txBox="1"/>
          <p:nvPr/>
        </p:nvSpPr>
        <p:spPr>
          <a:xfrm>
            <a:off x="-219284" y="667333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0B54D1-ECF5-44BA-D040-3FF003C9749D}"/>
              </a:ext>
            </a:extLst>
          </p:cNvPr>
          <p:cNvSpPr txBox="1"/>
          <p:nvPr/>
        </p:nvSpPr>
        <p:spPr>
          <a:xfrm>
            <a:off x="3063989" y="3789871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uration, month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770A4B1-5557-AA9B-5F87-9112FE2BF99E}"/>
              </a:ext>
            </a:extLst>
          </p:cNvPr>
          <p:cNvSpPr txBox="1"/>
          <p:nvPr/>
        </p:nvSpPr>
        <p:spPr>
          <a:xfrm>
            <a:off x="7381190" y="675180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F22558D-74A7-5960-F153-454C9F1105AA}"/>
              </a:ext>
            </a:extLst>
          </p:cNvPr>
          <p:cNvSpPr txBox="1"/>
          <p:nvPr/>
        </p:nvSpPr>
        <p:spPr>
          <a:xfrm>
            <a:off x="10799356" y="3784087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PUF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033E842-C30F-7816-0079-556AABAEDE8A}"/>
              </a:ext>
            </a:extLst>
          </p:cNvPr>
          <p:cNvSpPr txBox="1"/>
          <p:nvPr/>
        </p:nvSpPr>
        <p:spPr>
          <a:xfrm>
            <a:off x="-333745" y="4786084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071FA61-8B0B-FA22-0CD7-9994F4DA2047}"/>
              </a:ext>
            </a:extLst>
          </p:cNvPr>
          <p:cNvSpPr txBox="1"/>
          <p:nvPr/>
        </p:nvSpPr>
        <p:spPr>
          <a:xfrm>
            <a:off x="2456789" y="7801754"/>
            <a:ext cx="253041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Total amount of PUFA, g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00B3A7D-812D-1B8A-C9AE-21B11C6F0CCE}"/>
              </a:ext>
            </a:extLst>
          </p:cNvPr>
          <p:cNvSpPr txBox="1"/>
          <p:nvPr/>
        </p:nvSpPr>
        <p:spPr>
          <a:xfrm>
            <a:off x="7281936" y="4653035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25D1298-E5B5-2D7A-6F26-1D5A06135A79}"/>
              </a:ext>
            </a:extLst>
          </p:cNvPr>
          <p:cNvSpPr txBox="1"/>
          <p:nvPr/>
        </p:nvSpPr>
        <p:spPr>
          <a:xfrm>
            <a:off x="10648518" y="7801754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H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A6AF366-FC2C-12A0-F9BB-D52C42E66D0C}"/>
              </a:ext>
            </a:extLst>
          </p:cNvPr>
          <p:cNvSpPr txBox="1"/>
          <p:nvPr/>
        </p:nvSpPr>
        <p:spPr>
          <a:xfrm>
            <a:off x="-230833" y="8796618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C114EC2-AFEC-FCFC-90E4-7A339391A521}"/>
              </a:ext>
            </a:extLst>
          </p:cNvPr>
          <p:cNvSpPr txBox="1"/>
          <p:nvPr/>
        </p:nvSpPr>
        <p:spPr>
          <a:xfrm>
            <a:off x="2975330" y="11919911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EP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8DED6DA-3824-9FC5-F56C-8B9EE0701259}"/>
              </a:ext>
            </a:extLst>
          </p:cNvPr>
          <p:cNvSpPr txBox="1"/>
          <p:nvPr/>
        </p:nvSpPr>
        <p:spPr>
          <a:xfrm>
            <a:off x="7420436" y="8796618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5127524-4E8C-2A0B-2CE5-BC9976DB889C}"/>
              </a:ext>
            </a:extLst>
          </p:cNvPr>
          <p:cNvSpPr txBox="1"/>
          <p:nvPr/>
        </p:nvSpPr>
        <p:spPr>
          <a:xfrm>
            <a:off x="10836328" y="11919911"/>
            <a:ext cx="164099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HA/EPA ratio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21098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그룹 26">
            <a:extLst>
              <a:ext uri="{FF2B5EF4-FFF2-40B4-BE49-F238E27FC236}">
                <a16:creationId xmlns:a16="http://schemas.microsoft.com/office/drawing/2014/main" id="{CA1D50C2-77B4-7276-B6B5-BEC944FD214F}"/>
              </a:ext>
            </a:extLst>
          </p:cNvPr>
          <p:cNvGrpSpPr/>
          <p:nvPr/>
        </p:nvGrpSpPr>
        <p:grpSpPr>
          <a:xfrm>
            <a:off x="-217227" y="-1"/>
            <a:ext cx="15552478" cy="14585943"/>
            <a:chOff x="-217227" y="-1"/>
            <a:chExt cx="15552478" cy="14585943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CB88E437-E482-144B-6611-EEB26E36560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-1"/>
              <a:ext cx="7541753" cy="4105275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BACF9D73-B9DE-B18B-0379-D517262B3A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32322" y="4861979"/>
              <a:ext cx="7622499" cy="4885747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579E89CC-5E50-81E9-1E2C-1A6FCDBBC40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107681" y="9560418"/>
              <a:ext cx="7769095" cy="5025524"/>
            </a:xfrm>
            <a:prstGeom prst="rect">
              <a:avLst/>
            </a:prstGeom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D1C0C192-F506-FAB0-D329-DF1FA7CBE4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541753" y="9551065"/>
              <a:ext cx="7769096" cy="5025524"/>
            </a:xfrm>
            <a:prstGeom prst="rect">
              <a:avLst/>
            </a:prstGeom>
          </p:spPr>
        </p:pic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8078E336-D062-3EA9-5C71-892FA6BF6F2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39459" y="4731555"/>
              <a:ext cx="7895792" cy="5107480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56668DBB-B2F3-A9D3-A57B-4584C73AF34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590179" y="-1"/>
              <a:ext cx="7654820" cy="4166822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-217226" y="157811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7425121" y="5049547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425915" y="157811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-217226" y="5049547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107682" y="9775766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537666" y="9774072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271C424-BAE5-9DBC-929B-5C25685E03CD}"/>
                </a:ext>
              </a:extLst>
            </p:cNvPr>
            <p:cNvSpPr txBox="1"/>
            <p:nvPr/>
          </p:nvSpPr>
          <p:spPr>
            <a:xfrm>
              <a:off x="10558679" y="3811390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A23E7FF-2DF6-DCB1-45C6-EA7C631269C4}"/>
                </a:ext>
              </a:extLst>
            </p:cNvPr>
            <p:cNvSpPr txBox="1"/>
            <p:nvPr/>
          </p:nvSpPr>
          <p:spPr>
            <a:xfrm>
              <a:off x="3045954" y="382826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C83A01-560E-371F-5308-C2BAE9D843CF}"/>
                </a:ext>
              </a:extLst>
            </p:cNvPr>
            <p:cNvSpPr txBox="1"/>
            <p:nvPr/>
          </p:nvSpPr>
          <p:spPr>
            <a:xfrm>
              <a:off x="2923741" y="9373943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68B4BEA-8C0A-33BB-531C-13818656E74E}"/>
                </a:ext>
              </a:extLst>
            </p:cNvPr>
            <p:cNvSpPr txBox="1"/>
            <p:nvPr/>
          </p:nvSpPr>
          <p:spPr>
            <a:xfrm>
              <a:off x="10546240" y="9437212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F72E5C9-1A84-41F8-AC04-82D5D669D38E}"/>
                </a:ext>
              </a:extLst>
            </p:cNvPr>
            <p:cNvSpPr txBox="1"/>
            <p:nvPr/>
          </p:nvSpPr>
          <p:spPr>
            <a:xfrm>
              <a:off x="2923741" y="1410827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4F0084B-AAB3-83F9-C6D1-E6103C31F7D5}"/>
                </a:ext>
              </a:extLst>
            </p:cNvPr>
            <p:cNvSpPr txBox="1"/>
            <p:nvPr/>
          </p:nvSpPr>
          <p:spPr>
            <a:xfrm>
              <a:off x="10692836" y="1414814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err="1">
                  <a:latin typeface="Palatino Linotype" panose="02040502050505030304" pitchFamily="18" charset="0"/>
                </a:rPr>
                <a:t>Hedges’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3A12196-281B-5536-440B-C6346DC7C32C}"/>
                </a:ext>
              </a:extLst>
            </p:cNvPr>
            <p:cNvSpPr txBox="1"/>
            <p:nvPr/>
          </p:nvSpPr>
          <p:spPr>
            <a:xfrm>
              <a:off x="-217226" y="1172552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7F6909B-48AA-3325-2E2D-5E35ADAF142A}"/>
                </a:ext>
              </a:extLst>
            </p:cNvPr>
            <p:cNvSpPr txBox="1"/>
            <p:nvPr/>
          </p:nvSpPr>
          <p:spPr>
            <a:xfrm>
              <a:off x="7425915" y="1172551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DE07615-7543-E721-D6BE-6F0497D8BA2E}"/>
                </a:ext>
              </a:extLst>
            </p:cNvPr>
            <p:cNvSpPr txBox="1"/>
            <p:nvPr/>
          </p:nvSpPr>
          <p:spPr>
            <a:xfrm>
              <a:off x="-217226" y="6456456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AD2DC6F-587A-5FFC-F776-0B117B3D2FB6}"/>
                </a:ext>
              </a:extLst>
            </p:cNvPr>
            <p:cNvSpPr txBox="1"/>
            <p:nvPr/>
          </p:nvSpPr>
          <p:spPr>
            <a:xfrm>
              <a:off x="7322031" y="6456456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FFE7A48-94D1-5BE5-AAF9-FF86DE918286}"/>
                </a:ext>
              </a:extLst>
            </p:cNvPr>
            <p:cNvSpPr txBox="1"/>
            <p:nvPr/>
          </p:nvSpPr>
          <p:spPr>
            <a:xfrm>
              <a:off x="-217227" y="11178240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7532035-C0A7-81F9-BE14-B67942B374E4}"/>
                </a:ext>
              </a:extLst>
            </p:cNvPr>
            <p:cNvSpPr txBox="1"/>
            <p:nvPr/>
          </p:nvSpPr>
          <p:spPr>
            <a:xfrm>
              <a:off x="7425121" y="11178240"/>
              <a:ext cx="434451" cy="150948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Standard Error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55516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그림 19">
            <a:extLst>
              <a:ext uri="{FF2B5EF4-FFF2-40B4-BE49-F238E27FC236}">
                <a16:creationId xmlns:a16="http://schemas.microsoft.com/office/drawing/2014/main" id="{9CD00AE2-386A-465A-06D2-F3F824C7FC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8456" y="7503355"/>
            <a:ext cx="7112169" cy="3656728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4C4BDFCA-2746-8CC5-A3E4-B552ED7DE1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595188"/>
            <a:ext cx="7011006" cy="3604716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94FE4941-2118-8610-6116-4E68CFFDBF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3797594"/>
            <a:ext cx="7011007" cy="3604716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BEA302C7-3201-3EAF-A48F-DD6FF4C05A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11006" y="3705761"/>
            <a:ext cx="7189619" cy="3696549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8113E11D-519A-7F50-77CE-E9D4FB5259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-1"/>
            <a:ext cx="7011008" cy="3604716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D7E976A1-8BC8-21F8-B0E3-0B1F1ED35E1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11008" y="0"/>
            <a:ext cx="7011008" cy="360471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260941" y="0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a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973507" y="3795059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d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973507" y="-2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b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289655" y="3766166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c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260941" y="7688037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e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87794" y="7683503"/>
            <a:ext cx="6438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(f)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D6A8A6E-3890-68A0-6D97-28CE8E6246D5}"/>
              </a:ext>
            </a:extLst>
          </p:cNvPr>
          <p:cNvSpPr txBox="1"/>
          <p:nvPr/>
        </p:nvSpPr>
        <p:spPr>
          <a:xfrm>
            <a:off x="2791827" y="3160824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uration, month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2EBEFEE-AC62-FA33-1500-47AA8C98C1D5}"/>
              </a:ext>
            </a:extLst>
          </p:cNvPr>
          <p:cNvSpPr txBox="1"/>
          <p:nvPr/>
        </p:nvSpPr>
        <p:spPr>
          <a:xfrm>
            <a:off x="9802835" y="3160824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PUF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8A91CD-3539-D64E-9090-4E524181CA03}"/>
              </a:ext>
            </a:extLst>
          </p:cNvPr>
          <p:cNvSpPr txBox="1"/>
          <p:nvPr/>
        </p:nvSpPr>
        <p:spPr>
          <a:xfrm>
            <a:off x="-260941" y="440079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CA8B33-6448-9646-C00B-20C3350B73B5}"/>
              </a:ext>
            </a:extLst>
          </p:cNvPr>
          <p:cNvSpPr txBox="1"/>
          <p:nvPr/>
        </p:nvSpPr>
        <p:spPr>
          <a:xfrm>
            <a:off x="6941256" y="338554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5A8586-4934-529D-161E-87F7A2C743EF}"/>
              </a:ext>
            </a:extLst>
          </p:cNvPr>
          <p:cNvSpPr txBox="1"/>
          <p:nvPr/>
        </p:nvSpPr>
        <p:spPr>
          <a:xfrm>
            <a:off x="-260941" y="4151677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3E14EA-5738-0607-D8E4-1A2816B65BEB}"/>
              </a:ext>
            </a:extLst>
          </p:cNvPr>
          <p:cNvSpPr txBox="1"/>
          <p:nvPr/>
        </p:nvSpPr>
        <p:spPr>
          <a:xfrm>
            <a:off x="6941256" y="4104180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77D8D5-CDE4-38D2-762E-6417A6B8D59C}"/>
              </a:ext>
            </a:extLst>
          </p:cNvPr>
          <p:cNvSpPr txBox="1"/>
          <p:nvPr/>
        </p:nvSpPr>
        <p:spPr>
          <a:xfrm>
            <a:off x="2240297" y="6905497"/>
            <a:ext cx="253041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Total amount of PUFA, g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CED441-A1A4-7979-2FEE-293D44013E12}"/>
              </a:ext>
            </a:extLst>
          </p:cNvPr>
          <p:cNvSpPr txBox="1"/>
          <p:nvPr/>
        </p:nvSpPr>
        <p:spPr>
          <a:xfrm>
            <a:off x="9730139" y="7037343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H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5092E9D-CC84-7B2E-434A-A620BB17F1EE}"/>
              </a:ext>
            </a:extLst>
          </p:cNvPr>
          <p:cNvSpPr txBox="1"/>
          <p:nvPr/>
        </p:nvSpPr>
        <p:spPr>
          <a:xfrm>
            <a:off x="-260941" y="7954809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454F26-21BB-5824-9CE9-E0128088C7EE}"/>
              </a:ext>
            </a:extLst>
          </p:cNvPr>
          <p:cNvSpPr txBox="1"/>
          <p:nvPr/>
        </p:nvSpPr>
        <p:spPr>
          <a:xfrm>
            <a:off x="6871249" y="7954809"/>
            <a:ext cx="461665" cy="275382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 anchor="ctr" anchorCtr="1">
            <a:norm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Standardized Mean  Difference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AC5C10-307B-F3BA-5940-9F5ADBD823C6}"/>
              </a:ext>
            </a:extLst>
          </p:cNvPr>
          <p:cNvSpPr txBox="1"/>
          <p:nvPr/>
        </p:nvSpPr>
        <p:spPr>
          <a:xfrm>
            <a:off x="2621586" y="10796979"/>
            <a:ext cx="182880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EPA, mg/day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38ED46B-5705-2B1F-E13B-053868DEA7B0}"/>
              </a:ext>
            </a:extLst>
          </p:cNvPr>
          <p:cNvSpPr txBox="1"/>
          <p:nvPr/>
        </p:nvSpPr>
        <p:spPr>
          <a:xfrm>
            <a:off x="9917949" y="10796979"/>
            <a:ext cx="164099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Palatino Linotype" panose="02040502050505030304" pitchFamily="18" charset="0"/>
              </a:rPr>
              <a:t>DHA/EPA ratio</a:t>
            </a:r>
            <a:endParaRPr lang="ko-KR" altLang="en-US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3377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>
            <a:extLst>
              <a:ext uri="{FF2B5EF4-FFF2-40B4-BE49-F238E27FC236}">
                <a16:creationId xmlns:a16="http://schemas.microsoft.com/office/drawing/2014/main" id="{FDC43F09-75CA-C7CA-AC58-2B6D9FEFFE18}"/>
              </a:ext>
            </a:extLst>
          </p:cNvPr>
          <p:cNvGrpSpPr/>
          <p:nvPr/>
        </p:nvGrpSpPr>
        <p:grpSpPr>
          <a:xfrm>
            <a:off x="-250173" y="0"/>
            <a:ext cx="14390278" cy="11364036"/>
            <a:chOff x="-293716" y="-86436"/>
            <a:chExt cx="14390278" cy="11364036"/>
          </a:xfrm>
        </p:grpSpPr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707F7D5B-CC27-2B52-3D09-2DAD049A8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7595190"/>
              <a:ext cx="7162118" cy="3682410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647C3257-3D5F-B7B1-25D6-784CFD282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85552" y="7681627"/>
              <a:ext cx="6936464" cy="3566389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4F4CE56E-3E2C-8B45-5948-4C16C5AC97E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85552" y="3840813"/>
              <a:ext cx="7011009" cy="3604717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C790C8EA-BC53-F226-2F7A-8FAE511FF8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3844450"/>
              <a:ext cx="7011008" cy="3604717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48B32FE5-8514-EFC7-12AE-84995287644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085552" y="-1"/>
              <a:ext cx="7011010" cy="3604717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CE8672E6-D2F0-3D0B-3E09-65C085FC20B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0" y="0"/>
              <a:ext cx="7011008" cy="3604717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230833" y="-7882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817447" y="371719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817448" y="-86436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230833" y="371719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60941" y="7514226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823683" y="759155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9890CB3-3749-44D9-09A3-BB3759541FD7}"/>
                </a:ext>
              </a:extLst>
            </p:cNvPr>
            <p:cNvSpPr txBox="1"/>
            <p:nvPr/>
          </p:nvSpPr>
          <p:spPr>
            <a:xfrm>
              <a:off x="-230833" y="25973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F462012-1F5F-23C0-091C-F01A7142C1A5}"/>
                </a:ext>
              </a:extLst>
            </p:cNvPr>
            <p:cNvSpPr txBox="1"/>
            <p:nvPr/>
          </p:nvSpPr>
          <p:spPr>
            <a:xfrm>
              <a:off x="2787058" y="3181059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51A934A-D67A-DA69-FE03-F8A8BB671954}"/>
                </a:ext>
              </a:extLst>
            </p:cNvPr>
            <p:cNvSpPr txBox="1"/>
            <p:nvPr/>
          </p:nvSpPr>
          <p:spPr>
            <a:xfrm>
              <a:off x="9891972" y="3181059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EA1C49E-CF48-F079-4F8D-DF1DF1C2C4EC}"/>
                </a:ext>
              </a:extLst>
            </p:cNvPr>
            <p:cNvSpPr txBox="1"/>
            <p:nvPr/>
          </p:nvSpPr>
          <p:spPr>
            <a:xfrm>
              <a:off x="6817448" y="25973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B45371F-694A-0D1E-BF25-665CC4DB1126}"/>
                </a:ext>
              </a:extLst>
            </p:cNvPr>
            <p:cNvSpPr txBox="1"/>
            <p:nvPr/>
          </p:nvSpPr>
          <p:spPr>
            <a:xfrm>
              <a:off x="-260941" y="415167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587F728-6CD7-3914-5B77-286265DCD070}"/>
                </a:ext>
              </a:extLst>
            </p:cNvPr>
            <p:cNvSpPr txBox="1"/>
            <p:nvPr/>
          </p:nvSpPr>
          <p:spPr>
            <a:xfrm>
              <a:off x="6817447" y="4055752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BF9ADE5-6956-0742-E946-5C48C2B6007C}"/>
                </a:ext>
              </a:extLst>
            </p:cNvPr>
            <p:cNvSpPr txBox="1"/>
            <p:nvPr/>
          </p:nvSpPr>
          <p:spPr>
            <a:xfrm>
              <a:off x="2240296" y="7054796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B782339-406B-04E1-0013-B69566B27E5F}"/>
                </a:ext>
              </a:extLst>
            </p:cNvPr>
            <p:cNvSpPr txBox="1"/>
            <p:nvPr/>
          </p:nvSpPr>
          <p:spPr>
            <a:xfrm>
              <a:off x="9704162" y="705479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9BBF1F1-8B7F-6201-B9EA-11C77B4977BB}"/>
                </a:ext>
              </a:extLst>
            </p:cNvPr>
            <p:cNvSpPr txBox="1"/>
            <p:nvPr/>
          </p:nvSpPr>
          <p:spPr>
            <a:xfrm>
              <a:off x="-293716" y="795480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A95DF95-0EDC-4609-06B8-A4F2E6797B70}"/>
                </a:ext>
              </a:extLst>
            </p:cNvPr>
            <p:cNvSpPr txBox="1"/>
            <p:nvPr/>
          </p:nvSpPr>
          <p:spPr>
            <a:xfrm>
              <a:off x="6780175" y="795480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7F7693A-9A20-4B29-B46E-25482F2E3667}"/>
                </a:ext>
              </a:extLst>
            </p:cNvPr>
            <p:cNvSpPr txBox="1"/>
            <p:nvPr/>
          </p:nvSpPr>
          <p:spPr>
            <a:xfrm>
              <a:off x="2591101" y="10929552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BB7BF55-560F-5B92-0DBD-081FDFDA794A}"/>
                </a:ext>
              </a:extLst>
            </p:cNvPr>
            <p:cNvSpPr txBox="1"/>
            <p:nvPr/>
          </p:nvSpPr>
          <p:spPr>
            <a:xfrm>
              <a:off x="9891972" y="10862911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517744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>
            <a:extLst>
              <a:ext uri="{FF2B5EF4-FFF2-40B4-BE49-F238E27FC236}">
                <a16:creationId xmlns:a16="http://schemas.microsoft.com/office/drawing/2014/main" id="{06909AFA-FF43-7CC9-197A-8E304C42C04F}"/>
              </a:ext>
            </a:extLst>
          </p:cNvPr>
          <p:cNvGrpSpPr/>
          <p:nvPr/>
        </p:nvGrpSpPr>
        <p:grpSpPr>
          <a:xfrm>
            <a:off x="-271957" y="-32592"/>
            <a:ext cx="14343922" cy="11314995"/>
            <a:chOff x="-257443" y="-84944"/>
            <a:chExt cx="14343922" cy="11314995"/>
          </a:xfrm>
        </p:grpSpPr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4EA9333B-E634-39D8-9A8B-ADB81676C4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" y="7569319"/>
              <a:ext cx="7075472" cy="363786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75471" y="3553949"/>
              <a:ext cx="6853889" cy="3754739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346948F5-A791-6511-1972-9A9DFB8111E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3703973"/>
              <a:ext cx="7011006" cy="3604715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C2F54348-CF1F-9BA6-4D16-3F42CDB699B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011006" y="6410"/>
              <a:ext cx="7011007" cy="3604716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24C05E53-86DA-9B85-7D16-6B4F8F747CC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-1" y="6410"/>
              <a:ext cx="7011007" cy="3604716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075471" y="7366366"/>
              <a:ext cx="7011008" cy="384081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0" y="-8494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736639" y="371193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886369" y="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181845" y="371193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43532" y="761133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858824" y="761133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6E87A10-CF7B-5FE4-02A3-28C2DAEB2C9C}"/>
                </a:ext>
              </a:extLst>
            </p:cNvPr>
            <p:cNvSpPr txBox="1"/>
            <p:nvPr/>
          </p:nvSpPr>
          <p:spPr>
            <a:xfrm>
              <a:off x="-249275" y="28595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5099ED4-75A3-4E59-C3F4-319BB8C46AF3}"/>
                </a:ext>
              </a:extLst>
            </p:cNvPr>
            <p:cNvSpPr txBox="1"/>
            <p:nvPr/>
          </p:nvSpPr>
          <p:spPr>
            <a:xfrm>
              <a:off x="2787058" y="3181059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CAC2A0E-482D-ADB0-D403-9ED0B932F4AA}"/>
                </a:ext>
              </a:extLst>
            </p:cNvPr>
            <p:cNvSpPr txBox="1"/>
            <p:nvPr/>
          </p:nvSpPr>
          <p:spPr>
            <a:xfrm>
              <a:off x="6824323" y="25770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71D38C3-4227-B561-3F62-9F03913F2BD8}"/>
                </a:ext>
              </a:extLst>
            </p:cNvPr>
            <p:cNvSpPr txBox="1"/>
            <p:nvPr/>
          </p:nvSpPr>
          <p:spPr>
            <a:xfrm>
              <a:off x="9891972" y="3181059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2F2F7DB-F644-515A-5851-10C5096AA145}"/>
                </a:ext>
              </a:extLst>
            </p:cNvPr>
            <p:cNvSpPr txBox="1"/>
            <p:nvPr/>
          </p:nvSpPr>
          <p:spPr>
            <a:xfrm>
              <a:off x="-188253" y="4050488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0A4C537-8955-758C-774F-75D36F66328E}"/>
                </a:ext>
              </a:extLst>
            </p:cNvPr>
            <p:cNvSpPr txBox="1"/>
            <p:nvPr/>
          </p:nvSpPr>
          <p:spPr>
            <a:xfrm>
              <a:off x="6746610" y="405844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F0A0499-1DDC-5053-83BA-7442DBECA6B5}"/>
                </a:ext>
              </a:extLst>
            </p:cNvPr>
            <p:cNvSpPr txBox="1"/>
            <p:nvPr/>
          </p:nvSpPr>
          <p:spPr>
            <a:xfrm>
              <a:off x="9588014" y="6970134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3AD267A-C54E-05DD-49F0-349E67052D96}"/>
                </a:ext>
              </a:extLst>
            </p:cNvPr>
            <p:cNvSpPr txBox="1"/>
            <p:nvPr/>
          </p:nvSpPr>
          <p:spPr>
            <a:xfrm>
              <a:off x="2240296" y="6970134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14FCA58-3BD2-137F-8E13-213861F107A0}"/>
                </a:ext>
              </a:extLst>
            </p:cNvPr>
            <p:cNvSpPr txBox="1"/>
            <p:nvPr/>
          </p:nvSpPr>
          <p:spPr>
            <a:xfrm>
              <a:off x="-257443" y="791093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B5B0928-E064-BFDA-D605-92316EB49D5D}"/>
                </a:ext>
              </a:extLst>
            </p:cNvPr>
            <p:cNvSpPr txBox="1"/>
            <p:nvPr/>
          </p:nvSpPr>
          <p:spPr>
            <a:xfrm>
              <a:off x="6824323" y="791093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2F70678-92B4-1A01-C207-921FC8E0CE18}"/>
                </a:ext>
              </a:extLst>
            </p:cNvPr>
            <p:cNvSpPr txBox="1"/>
            <p:nvPr/>
          </p:nvSpPr>
          <p:spPr>
            <a:xfrm>
              <a:off x="2591101" y="10868251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88FB998-D41A-5511-1C0B-C6DA108A3BBF}"/>
                </a:ext>
              </a:extLst>
            </p:cNvPr>
            <p:cNvSpPr txBox="1"/>
            <p:nvPr/>
          </p:nvSpPr>
          <p:spPr>
            <a:xfrm>
              <a:off x="9935515" y="10891497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42931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그룹 26">
            <a:extLst>
              <a:ext uri="{FF2B5EF4-FFF2-40B4-BE49-F238E27FC236}">
                <a16:creationId xmlns:a16="http://schemas.microsoft.com/office/drawing/2014/main" id="{116FD8C9-2701-1786-D573-5354467FFDAE}"/>
              </a:ext>
            </a:extLst>
          </p:cNvPr>
          <p:cNvGrpSpPr/>
          <p:nvPr/>
        </p:nvGrpSpPr>
        <p:grpSpPr>
          <a:xfrm>
            <a:off x="-303822" y="0"/>
            <a:ext cx="15680272" cy="11947542"/>
            <a:chOff x="-303822" y="0"/>
            <a:chExt cx="15680272" cy="11947542"/>
          </a:xfrm>
        </p:grpSpPr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2142FBE4-A458-37D9-1340-AD599C324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01340" y="7951646"/>
              <a:ext cx="7675110" cy="3946165"/>
            </a:xfrm>
            <a:prstGeom prst="rect">
              <a:avLst/>
            </a:prstGeom>
          </p:spPr>
        </p:pic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BABF296C-C30B-2D79-8B6E-8491A7B84B7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8001377"/>
              <a:ext cx="7675110" cy="3946165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C2D6584B-ED23-98B2-27BF-BAEABF1A45C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86810" y="4005481"/>
              <a:ext cx="7675110" cy="3946165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47BEFDA5-098E-ABE6-B098-9E21C0F434B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4005481"/>
              <a:ext cx="7604758" cy="3909994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F46C22E0-4AA6-557D-3355-D63595ED1B0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689640" y="0"/>
              <a:ext cx="7604758" cy="3909993"/>
            </a:xfrm>
            <a:prstGeom prst="rect">
              <a:avLst/>
            </a:prstGeom>
          </p:spPr>
        </p:pic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721EB23A-154C-962E-050C-C531A47B141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0" y="0"/>
              <a:ext cx="7543660" cy="387858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299835" y="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446878" y="405948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604758" y="17122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299835" y="406219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57063" y="802266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562542" y="801773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60E6DCA-D07B-56A3-2B98-050C67CE9811}"/>
                </a:ext>
              </a:extLst>
            </p:cNvPr>
            <p:cNvSpPr txBox="1"/>
            <p:nvPr/>
          </p:nvSpPr>
          <p:spPr>
            <a:xfrm>
              <a:off x="-303822" y="359016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CF41D65-34FF-A812-A365-4CFE86243010}"/>
                </a:ext>
              </a:extLst>
            </p:cNvPr>
            <p:cNvSpPr txBox="1"/>
            <p:nvPr/>
          </p:nvSpPr>
          <p:spPr>
            <a:xfrm>
              <a:off x="3062829" y="3413700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C85EA30-1850-EA93-9DBF-9D0510867EAE}"/>
                </a:ext>
              </a:extLst>
            </p:cNvPr>
            <p:cNvSpPr txBox="1"/>
            <p:nvPr/>
          </p:nvSpPr>
          <p:spPr>
            <a:xfrm>
              <a:off x="7572849" y="383356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7137F55-1DB4-CBE0-021F-6E3EF0F6147F}"/>
                </a:ext>
              </a:extLst>
            </p:cNvPr>
            <p:cNvSpPr txBox="1"/>
            <p:nvPr/>
          </p:nvSpPr>
          <p:spPr>
            <a:xfrm>
              <a:off x="10864429" y="344990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CDB01D-FC52-2F9A-5572-6E11B7F785B8}"/>
                </a:ext>
              </a:extLst>
            </p:cNvPr>
            <p:cNvSpPr txBox="1"/>
            <p:nvPr/>
          </p:nvSpPr>
          <p:spPr>
            <a:xfrm>
              <a:off x="-303822" y="4400744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A26AFF7-69D8-4C2C-BD29-E1F567145216}"/>
                </a:ext>
              </a:extLst>
            </p:cNvPr>
            <p:cNvSpPr txBox="1"/>
            <p:nvPr/>
          </p:nvSpPr>
          <p:spPr>
            <a:xfrm>
              <a:off x="2506624" y="7482578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83732B6-B997-0F41-6839-803AD99A697D}"/>
                </a:ext>
              </a:extLst>
            </p:cNvPr>
            <p:cNvSpPr txBox="1"/>
            <p:nvPr/>
          </p:nvSpPr>
          <p:spPr>
            <a:xfrm>
              <a:off x="7547051" y="4457453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6A8AA02-0DEB-9C28-82BD-222B121C7B1F}"/>
                </a:ext>
              </a:extLst>
            </p:cNvPr>
            <p:cNvSpPr txBox="1"/>
            <p:nvPr/>
          </p:nvSpPr>
          <p:spPr>
            <a:xfrm>
              <a:off x="10624494" y="748663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8CC07A7-5AFC-2C7E-980B-1ACA12981422}"/>
                </a:ext>
              </a:extLst>
            </p:cNvPr>
            <p:cNvSpPr txBox="1"/>
            <p:nvPr/>
          </p:nvSpPr>
          <p:spPr>
            <a:xfrm>
              <a:off x="-257063" y="836121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388C4E7-D0E3-0877-B3E7-61E1F433FCF3}"/>
                </a:ext>
              </a:extLst>
            </p:cNvPr>
            <p:cNvSpPr txBox="1"/>
            <p:nvPr/>
          </p:nvSpPr>
          <p:spPr>
            <a:xfrm>
              <a:off x="2857429" y="11432802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49D8DE9-CD20-610D-71B5-9A99A43E0BE2}"/>
                </a:ext>
              </a:extLst>
            </p:cNvPr>
            <p:cNvSpPr txBox="1"/>
            <p:nvPr/>
          </p:nvSpPr>
          <p:spPr>
            <a:xfrm>
              <a:off x="7433091" y="445876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047B097-E935-F9D4-E425-FB373853FEDA}"/>
                </a:ext>
              </a:extLst>
            </p:cNvPr>
            <p:cNvSpPr txBox="1"/>
            <p:nvPr/>
          </p:nvSpPr>
          <p:spPr>
            <a:xfrm>
              <a:off x="7524164" y="836121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9D324D3-D784-90BF-9EED-A8C479B0855D}"/>
                </a:ext>
              </a:extLst>
            </p:cNvPr>
            <p:cNvSpPr txBox="1"/>
            <p:nvPr/>
          </p:nvSpPr>
          <p:spPr>
            <a:xfrm>
              <a:off x="10864429" y="11432802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784140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그룹 26">
            <a:extLst>
              <a:ext uri="{FF2B5EF4-FFF2-40B4-BE49-F238E27FC236}">
                <a16:creationId xmlns:a16="http://schemas.microsoft.com/office/drawing/2014/main" id="{C225A7D8-37A7-A318-A799-97BF37F313B4}"/>
              </a:ext>
            </a:extLst>
          </p:cNvPr>
          <p:cNvGrpSpPr/>
          <p:nvPr/>
        </p:nvGrpSpPr>
        <p:grpSpPr>
          <a:xfrm>
            <a:off x="-323496" y="-1"/>
            <a:ext cx="15441574" cy="11831391"/>
            <a:chOff x="-323496" y="-1"/>
            <a:chExt cx="15441574" cy="11831391"/>
          </a:xfrm>
        </p:grpSpPr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8CEF39D0-2690-46B4-5100-F98823D31D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53049" y="7921396"/>
              <a:ext cx="7416738" cy="3813323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036E09C2-091F-9619-BF3B-00B7C11BC86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2" y="7921396"/>
              <a:ext cx="7604759" cy="3909994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B2069861-9CB9-3EC0-24BD-7302D17BE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86810" y="3941755"/>
              <a:ext cx="7416738" cy="3813323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FDBF9014-EFAD-5115-5484-6C7C96763E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1" y="3941755"/>
              <a:ext cx="7513322" cy="3862982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DD4080E9-506D-65EB-50E2-196BA104EDA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604758" y="-1"/>
              <a:ext cx="7513320" cy="3862981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E92D5651-95E7-1081-9A3A-364CDB52EA7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" y="0"/>
              <a:ext cx="7513320" cy="3862981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300212" y="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514910" y="4045242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513321" y="2479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323496" y="404384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96955" y="8096961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487722" y="811259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3398D8D-868B-9329-CED5-665F298AFD0E}"/>
                </a:ext>
              </a:extLst>
            </p:cNvPr>
            <p:cNvSpPr txBox="1"/>
            <p:nvPr/>
          </p:nvSpPr>
          <p:spPr>
            <a:xfrm>
              <a:off x="-304199" y="360388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8382EAC-3106-41FC-EAC5-70F0ED540CDB}"/>
                </a:ext>
              </a:extLst>
            </p:cNvPr>
            <p:cNvSpPr txBox="1"/>
            <p:nvPr/>
          </p:nvSpPr>
          <p:spPr>
            <a:xfrm>
              <a:off x="3062829" y="3413700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F1DB3FF-B80B-41BD-0902-E34D8B2AFD1D}"/>
                </a:ext>
              </a:extLst>
            </p:cNvPr>
            <p:cNvSpPr txBox="1"/>
            <p:nvPr/>
          </p:nvSpPr>
          <p:spPr>
            <a:xfrm>
              <a:off x="7469187" y="360388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04BFBCB-C067-AA62-32E8-A6D44B6A2CEE}"/>
                </a:ext>
              </a:extLst>
            </p:cNvPr>
            <p:cNvSpPr txBox="1"/>
            <p:nvPr/>
          </p:nvSpPr>
          <p:spPr>
            <a:xfrm>
              <a:off x="10690258" y="3413700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9CC6224-1FD7-8B21-0C24-CDD687545245}"/>
                </a:ext>
              </a:extLst>
            </p:cNvPr>
            <p:cNvSpPr txBox="1"/>
            <p:nvPr/>
          </p:nvSpPr>
          <p:spPr>
            <a:xfrm>
              <a:off x="-296955" y="435063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B28A69-0972-0A14-709D-79A698D5A7C0}"/>
                </a:ext>
              </a:extLst>
            </p:cNvPr>
            <p:cNvSpPr txBox="1"/>
            <p:nvPr/>
          </p:nvSpPr>
          <p:spPr>
            <a:xfrm>
              <a:off x="7513321" y="4374956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FA75073-1F7F-BFDD-8F24-95914FC9A2C2}"/>
                </a:ext>
              </a:extLst>
            </p:cNvPr>
            <p:cNvSpPr txBox="1"/>
            <p:nvPr/>
          </p:nvSpPr>
          <p:spPr>
            <a:xfrm>
              <a:off x="10502448" y="7337749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C5EB6E-7C8A-845B-5615-AB14D4116E1B}"/>
                </a:ext>
              </a:extLst>
            </p:cNvPr>
            <p:cNvSpPr txBox="1"/>
            <p:nvPr/>
          </p:nvSpPr>
          <p:spPr>
            <a:xfrm>
              <a:off x="2491454" y="7366816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86769BE-D6FD-10D3-DE10-EBB27ECC57FA}"/>
                </a:ext>
              </a:extLst>
            </p:cNvPr>
            <p:cNvSpPr txBox="1"/>
            <p:nvPr/>
          </p:nvSpPr>
          <p:spPr>
            <a:xfrm>
              <a:off x="-301706" y="845114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B07A0AE-0656-469D-98D1-FA726A9FCC99}"/>
                </a:ext>
              </a:extLst>
            </p:cNvPr>
            <p:cNvSpPr txBox="1"/>
            <p:nvPr/>
          </p:nvSpPr>
          <p:spPr>
            <a:xfrm>
              <a:off x="2842259" y="1149283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CF419A9-E6F5-3B52-F6B3-39AB3C50DC12}"/>
                </a:ext>
              </a:extLst>
            </p:cNvPr>
            <p:cNvSpPr txBox="1"/>
            <p:nvPr/>
          </p:nvSpPr>
          <p:spPr>
            <a:xfrm>
              <a:off x="7440045" y="845114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9A88C81-40E9-6D55-85DC-169CF209E455}"/>
                </a:ext>
              </a:extLst>
            </p:cNvPr>
            <p:cNvSpPr txBox="1"/>
            <p:nvPr/>
          </p:nvSpPr>
          <p:spPr>
            <a:xfrm>
              <a:off x="10690258" y="11396165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109131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그룹 26">
            <a:extLst>
              <a:ext uri="{FF2B5EF4-FFF2-40B4-BE49-F238E27FC236}">
                <a16:creationId xmlns:a16="http://schemas.microsoft.com/office/drawing/2014/main" id="{688409A7-3868-62FA-BF3A-A4721490DF42}"/>
              </a:ext>
            </a:extLst>
          </p:cNvPr>
          <p:cNvGrpSpPr/>
          <p:nvPr/>
        </p:nvGrpSpPr>
        <p:grpSpPr>
          <a:xfrm>
            <a:off x="-242533" y="16445"/>
            <a:ext cx="15662891" cy="11927960"/>
            <a:chOff x="-242533" y="16445"/>
            <a:chExt cx="15662891" cy="11927960"/>
          </a:xfrm>
        </p:grpSpPr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702FC959-15ED-0019-774C-A1EF472618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255" y="7978739"/>
              <a:ext cx="7713039" cy="3965666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876FEE9D-0538-50B5-C182-743E50BB268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33549" y="7992225"/>
              <a:ext cx="7686809" cy="3952180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035AF7C4-13A7-2BD5-BAED-D39733A5859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723295" y="3861394"/>
              <a:ext cx="7686809" cy="3952180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E8BFA1ED-FFC6-3CB0-AC8A-352DAC0D737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3883214"/>
              <a:ext cx="7686810" cy="395218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C19646C1-1164-E7DA-A70C-2BBFF220164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701340" y="16445"/>
              <a:ext cx="7654600" cy="393562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754942B7-6E8B-3C69-9574-C7F81A5C448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255" y="26910"/>
              <a:ext cx="7654600" cy="393562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211176" y="2691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658441" y="3976016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658441" y="17331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213903" y="3978385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90645" y="814030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520376" y="8140308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4342BB0-3447-569D-E647-57799F6B7902}"/>
                </a:ext>
              </a:extLst>
            </p:cNvPr>
            <p:cNvSpPr txBox="1"/>
            <p:nvPr/>
          </p:nvSpPr>
          <p:spPr>
            <a:xfrm>
              <a:off x="-242533" y="43198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AB3D667-4953-CEB2-846B-A0807FE20243}"/>
                </a:ext>
              </a:extLst>
            </p:cNvPr>
            <p:cNvSpPr txBox="1"/>
            <p:nvPr/>
          </p:nvSpPr>
          <p:spPr>
            <a:xfrm>
              <a:off x="3077344" y="3472988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99FFD98-C819-FEBF-0F5C-6ABFA48C8856}"/>
                </a:ext>
              </a:extLst>
            </p:cNvPr>
            <p:cNvSpPr txBox="1"/>
            <p:nvPr/>
          </p:nvSpPr>
          <p:spPr>
            <a:xfrm>
              <a:off x="7647176" y="51186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24822E9-210A-8557-34B9-A3EDCE18A12F}"/>
                </a:ext>
              </a:extLst>
            </p:cNvPr>
            <p:cNvSpPr txBox="1"/>
            <p:nvPr/>
          </p:nvSpPr>
          <p:spPr>
            <a:xfrm>
              <a:off x="10864430" y="3472988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7B82ADA-2976-DC25-96D3-7BF2147195F4}"/>
                </a:ext>
              </a:extLst>
            </p:cNvPr>
            <p:cNvSpPr txBox="1"/>
            <p:nvPr/>
          </p:nvSpPr>
          <p:spPr>
            <a:xfrm>
              <a:off x="-235475" y="431693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D8BA748-27E6-6025-54A2-7CC2EAC43BA7}"/>
                </a:ext>
              </a:extLst>
            </p:cNvPr>
            <p:cNvSpPr txBox="1"/>
            <p:nvPr/>
          </p:nvSpPr>
          <p:spPr>
            <a:xfrm>
              <a:off x="2458049" y="7322049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F741B94-5591-7682-93D6-9DAD718F84CE}"/>
                </a:ext>
              </a:extLst>
            </p:cNvPr>
            <p:cNvSpPr txBox="1"/>
            <p:nvPr/>
          </p:nvSpPr>
          <p:spPr>
            <a:xfrm>
              <a:off x="7645402" y="4388611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EB4DF84-AD70-6964-410A-D9CFF5052831}"/>
                </a:ext>
              </a:extLst>
            </p:cNvPr>
            <p:cNvSpPr txBox="1"/>
            <p:nvPr/>
          </p:nvSpPr>
          <p:spPr>
            <a:xfrm>
              <a:off x="10662552" y="731793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3DB2055-AED4-D7B8-478B-4668DE07673A}"/>
                </a:ext>
              </a:extLst>
            </p:cNvPr>
            <p:cNvSpPr txBox="1"/>
            <p:nvPr/>
          </p:nvSpPr>
          <p:spPr>
            <a:xfrm>
              <a:off x="2952373" y="1148924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488A7A3-D992-811A-9DB8-56CBBD23EFB5}"/>
                </a:ext>
              </a:extLst>
            </p:cNvPr>
            <p:cNvSpPr txBox="1"/>
            <p:nvPr/>
          </p:nvSpPr>
          <p:spPr>
            <a:xfrm>
              <a:off x="-95424" y="8478862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C39E714-7500-61C4-7883-05F6B1D81627}"/>
                </a:ext>
              </a:extLst>
            </p:cNvPr>
            <p:cNvSpPr txBox="1"/>
            <p:nvPr/>
          </p:nvSpPr>
          <p:spPr>
            <a:xfrm>
              <a:off x="7518682" y="8478862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6431D91-5728-F291-78CF-8EC4066180F5}"/>
                </a:ext>
              </a:extLst>
            </p:cNvPr>
            <p:cNvSpPr txBox="1"/>
            <p:nvPr/>
          </p:nvSpPr>
          <p:spPr>
            <a:xfrm>
              <a:off x="10958334" y="11489246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330102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그룹 21">
            <a:extLst>
              <a:ext uri="{FF2B5EF4-FFF2-40B4-BE49-F238E27FC236}">
                <a16:creationId xmlns:a16="http://schemas.microsoft.com/office/drawing/2014/main" id="{E3D2206C-104D-5AE5-B1B9-A87A801DB80F}"/>
              </a:ext>
            </a:extLst>
          </p:cNvPr>
          <p:cNvGrpSpPr/>
          <p:nvPr/>
        </p:nvGrpSpPr>
        <p:grpSpPr>
          <a:xfrm>
            <a:off x="-252605" y="-1"/>
            <a:ext cx="14750012" cy="11930067"/>
            <a:chOff x="-252605" y="-1"/>
            <a:chExt cx="14750012" cy="11930067"/>
          </a:xfrm>
        </p:grpSpPr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6D0E9D02-5F2C-18BC-AA1C-06227B5589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8140308"/>
              <a:ext cx="6981825" cy="3789758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32150885-AFC4-F80E-F294-9D502CFD041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04756" y="4059621"/>
              <a:ext cx="6892651" cy="3741354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2BE87421-984F-4773-D98B-622D35304B0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1" y="4059622"/>
              <a:ext cx="6981825" cy="3789759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03BFBB8F-96F6-EA19-F156-4070BFF2256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604758" y="-1"/>
              <a:ext cx="6877051" cy="3732887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4D34FE6B-7DFE-4913-09B6-7C0E7AC4412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0" y="0"/>
              <a:ext cx="6877050" cy="3732886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230836" y="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349647" y="421819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386311" y="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230836" y="421939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30836" y="831972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9201B9B-5C82-0835-80C3-A2E4B006F3A2}"/>
                </a:ext>
              </a:extLst>
            </p:cNvPr>
            <p:cNvSpPr txBox="1"/>
            <p:nvPr/>
          </p:nvSpPr>
          <p:spPr>
            <a:xfrm>
              <a:off x="-230834" y="338554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1A6126F-0784-2555-1EE5-F8F2BC1E3F34}"/>
                </a:ext>
              </a:extLst>
            </p:cNvPr>
            <p:cNvSpPr txBox="1"/>
            <p:nvPr/>
          </p:nvSpPr>
          <p:spPr>
            <a:xfrm>
              <a:off x="2758442" y="3409926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2E7A83F-A4DA-CEA8-138A-FDD38089459B}"/>
                </a:ext>
              </a:extLst>
            </p:cNvPr>
            <p:cNvSpPr txBox="1"/>
            <p:nvPr/>
          </p:nvSpPr>
          <p:spPr>
            <a:xfrm>
              <a:off x="9661588" y="3409926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C9B8ED1-D77D-F4BD-2432-6878AE053B84}"/>
                </a:ext>
              </a:extLst>
            </p:cNvPr>
            <p:cNvSpPr txBox="1"/>
            <p:nvPr/>
          </p:nvSpPr>
          <p:spPr>
            <a:xfrm>
              <a:off x="7349647" y="338554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252AA65-FAD0-09DE-0860-5E2047F9D516}"/>
                </a:ext>
              </a:extLst>
            </p:cNvPr>
            <p:cNvSpPr txBox="1"/>
            <p:nvPr/>
          </p:nvSpPr>
          <p:spPr>
            <a:xfrm>
              <a:off x="-252604" y="454970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2FD4DD6-EFC5-13F3-023F-D4DEB8D66B30}"/>
                </a:ext>
              </a:extLst>
            </p:cNvPr>
            <p:cNvSpPr txBox="1"/>
            <p:nvPr/>
          </p:nvSpPr>
          <p:spPr>
            <a:xfrm>
              <a:off x="2524124" y="751082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25B46A4-8710-2DDA-151D-35764DC73811}"/>
                </a:ext>
              </a:extLst>
            </p:cNvPr>
            <p:cNvSpPr txBox="1"/>
            <p:nvPr/>
          </p:nvSpPr>
          <p:spPr>
            <a:xfrm>
              <a:off x="10128882" y="7462421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AB62A2D-CE12-493C-6B7E-F334E90B9E02}"/>
                </a:ext>
              </a:extLst>
            </p:cNvPr>
            <p:cNvSpPr txBox="1"/>
            <p:nvPr/>
          </p:nvSpPr>
          <p:spPr>
            <a:xfrm>
              <a:off x="7306105" y="4549709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1EC0E95-5D91-7427-447F-343E791022FF}"/>
                </a:ext>
              </a:extLst>
            </p:cNvPr>
            <p:cNvSpPr txBox="1"/>
            <p:nvPr/>
          </p:nvSpPr>
          <p:spPr>
            <a:xfrm>
              <a:off x="-252605" y="865827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D9818E0-93BF-C2EE-D8B5-7EEB0A27456B}"/>
                </a:ext>
              </a:extLst>
            </p:cNvPr>
            <p:cNvSpPr txBox="1"/>
            <p:nvPr/>
          </p:nvSpPr>
          <p:spPr>
            <a:xfrm>
              <a:off x="2788198" y="11591512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079796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>
            <a:extLst>
              <a:ext uri="{FF2B5EF4-FFF2-40B4-BE49-F238E27FC236}">
                <a16:creationId xmlns:a16="http://schemas.microsoft.com/office/drawing/2014/main" id="{5A3F535B-A23B-84A8-12A2-DD1EBF3741A6}"/>
              </a:ext>
            </a:extLst>
          </p:cNvPr>
          <p:cNvGrpSpPr/>
          <p:nvPr/>
        </p:nvGrpSpPr>
        <p:grpSpPr>
          <a:xfrm>
            <a:off x="-291413" y="9759"/>
            <a:ext cx="15729511" cy="12322394"/>
            <a:chOff x="-291413" y="9759"/>
            <a:chExt cx="15729511" cy="12322394"/>
          </a:xfrm>
        </p:grpSpPr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F70469EE-B27F-DE3B-2ACE-B8E6933ED2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42151" y="8100486"/>
              <a:ext cx="7795947" cy="4231666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E2F3A94E-0C0D-7A0D-1436-483838DDC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8133369"/>
              <a:ext cx="7735368" cy="4198784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DC271EB2-2773-6A66-1A46-849C3B21BC0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12023" y="3934586"/>
              <a:ext cx="7735367" cy="4198783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5AD9C679-EC52-51D7-AFBC-943D9449149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265" y="4005481"/>
              <a:ext cx="7604758" cy="4127888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D135EA89-BB52-ED8A-1C7F-A13F2253AC1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672280" y="9759"/>
              <a:ext cx="7675110" cy="4166075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F2A8F93B-183F-B282-ED22-FD2659D5E3E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265" y="9934"/>
              <a:ext cx="7604758" cy="412788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-239230" y="233839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a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432418" y="4177360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d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413462" y="233839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b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219284" y="4175834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c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43148" y="8459693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e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490497" y="8499237"/>
              <a:ext cx="6438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Palatino Linotype" panose="02040502050505030304" pitchFamily="18" charset="0"/>
                </a:rPr>
                <a:t>(f)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C1FE4AF-5FA7-9329-B87A-5DA83E4923BB}"/>
                </a:ext>
              </a:extLst>
            </p:cNvPr>
            <p:cNvSpPr txBox="1"/>
            <p:nvPr/>
          </p:nvSpPr>
          <p:spPr>
            <a:xfrm>
              <a:off x="-291413" y="667563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129C450-2A7A-15FE-E63F-8867A6DD83F7}"/>
                </a:ext>
              </a:extLst>
            </p:cNvPr>
            <p:cNvSpPr txBox="1"/>
            <p:nvPr/>
          </p:nvSpPr>
          <p:spPr>
            <a:xfrm>
              <a:off x="10799356" y="3784087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PUF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0915D99-4DBC-BAFB-3D6D-3921B1DF296F}"/>
                </a:ext>
              </a:extLst>
            </p:cNvPr>
            <p:cNvSpPr txBox="1"/>
            <p:nvPr/>
          </p:nvSpPr>
          <p:spPr>
            <a:xfrm>
              <a:off x="3063989" y="3789871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uration, month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7FE662C-D6BB-C528-8095-C9649B441E72}"/>
                </a:ext>
              </a:extLst>
            </p:cNvPr>
            <p:cNvSpPr txBox="1"/>
            <p:nvPr/>
          </p:nvSpPr>
          <p:spPr>
            <a:xfrm>
              <a:off x="7396853" y="675180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CBEBA04-30D0-01F4-4FC1-C7A3B22D4EDC}"/>
                </a:ext>
              </a:extLst>
            </p:cNvPr>
            <p:cNvSpPr txBox="1"/>
            <p:nvPr/>
          </p:nvSpPr>
          <p:spPr>
            <a:xfrm>
              <a:off x="-219284" y="4563628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791688B-B6CE-F81F-614C-B885FD1602F2}"/>
                </a:ext>
              </a:extLst>
            </p:cNvPr>
            <p:cNvSpPr txBox="1"/>
            <p:nvPr/>
          </p:nvSpPr>
          <p:spPr>
            <a:xfrm>
              <a:off x="2456789" y="7801754"/>
              <a:ext cx="253041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Total amount of PUFA, g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28C42E9-9FD1-7ABC-D3EC-E5C45544BDD1}"/>
                </a:ext>
              </a:extLst>
            </p:cNvPr>
            <p:cNvSpPr txBox="1"/>
            <p:nvPr/>
          </p:nvSpPr>
          <p:spPr>
            <a:xfrm>
              <a:off x="7396852" y="4555452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28493F8-1FB6-0DE8-5310-DD2080490EF2}"/>
                </a:ext>
              </a:extLst>
            </p:cNvPr>
            <p:cNvSpPr txBox="1"/>
            <p:nvPr/>
          </p:nvSpPr>
          <p:spPr>
            <a:xfrm>
              <a:off x="10565305" y="7801754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D79BB1E-4AC4-9188-BC5A-7FF785B14272}"/>
                </a:ext>
              </a:extLst>
            </p:cNvPr>
            <p:cNvSpPr txBox="1"/>
            <p:nvPr/>
          </p:nvSpPr>
          <p:spPr>
            <a:xfrm>
              <a:off x="-291413" y="8839927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2CAACC8-D5E4-D89D-1BBD-3B1CC1B48BD0}"/>
                </a:ext>
              </a:extLst>
            </p:cNvPr>
            <p:cNvSpPr txBox="1"/>
            <p:nvPr/>
          </p:nvSpPr>
          <p:spPr>
            <a:xfrm>
              <a:off x="2906675" y="11993598"/>
              <a:ext cx="18288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EPA, mg/day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BB34C6D-B142-0FAE-05C5-EF95FC169BA7}"/>
                </a:ext>
              </a:extLst>
            </p:cNvPr>
            <p:cNvSpPr txBox="1"/>
            <p:nvPr/>
          </p:nvSpPr>
          <p:spPr>
            <a:xfrm>
              <a:off x="7455977" y="8855851"/>
              <a:ext cx="461665" cy="275382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 anchor="ctr" anchorCtr="1">
              <a:normAutofit/>
            </a:bodyPr>
            <a:lstStyle/>
            <a:p>
              <a:r>
                <a:rPr lang="en-US" altLang="ko-KR" sz="1400" dirty="0">
                  <a:latin typeface="Palatino Linotype" panose="02040502050505030304" pitchFamily="18" charset="0"/>
                </a:rPr>
                <a:t>Standardized Mean  Difference</a:t>
              </a:r>
              <a:endParaRPr lang="ko-KR" altLang="en-US" sz="1400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E00EF92-B6A6-F2B9-68CD-C17B40870D02}"/>
                </a:ext>
              </a:extLst>
            </p:cNvPr>
            <p:cNvSpPr txBox="1"/>
            <p:nvPr/>
          </p:nvSpPr>
          <p:spPr>
            <a:xfrm>
              <a:off x="10893260" y="11993598"/>
              <a:ext cx="16409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>
                  <a:latin typeface="Palatino Linotype" panose="02040502050505030304" pitchFamily="18" charset="0"/>
                </a:rPr>
                <a:t>DHA/EPA ratio</a:t>
              </a:r>
              <a:endParaRPr lang="ko-KR" altLang="en-US" sz="1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90424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453</TotalTime>
  <Words>623</Words>
  <Application>Microsoft Office PowerPoint</Application>
  <PresentationFormat>Widescreen</PresentationFormat>
  <Paragraphs>218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맑은 고딕</vt:lpstr>
      <vt:lpstr>Arial</vt:lpstr>
      <vt:lpstr>Palatino Linotype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임 은지</dc:creator>
  <cp:lastModifiedBy>Dina Jaro</cp:lastModifiedBy>
  <cp:revision>352</cp:revision>
  <dcterms:created xsi:type="dcterms:W3CDTF">2021-03-03T00:51:41Z</dcterms:created>
  <dcterms:modified xsi:type="dcterms:W3CDTF">2024-03-06T04:05:23Z</dcterms:modified>
</cp:coreProperties>
</file>